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  <p:sldId id="263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610"/>
    <p:restoredTop sz="95988"/>
  </p:normalViewPr>
  <p:slideViewPr>
    <p:cSldViewPr snapToGrid="0" snapToObjects="1">
      <p:cViewPr varScale="1">
        <p:scale>
          <a:sx n="65" d="100"/>
          <a:sy n="65" d="100"/>
        </p:scale>
        <p:origin x="3464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538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301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895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033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44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762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208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30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950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876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2904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C287E5-A476-E142-819A-FF22DE80739D}" type="datetimeFigureOut">
              <a:rPr lang="en-US" smtClean="0"/>
              <a:t>6/1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B31B94-0A9F-934E-9AB3-4B4EDB5511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110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BDE755D-F68E-214B-896A-4383A100C21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6792" b="55195"/>
          <a:stretch/>
        </p:blipFill>
        <p:spPr>
          <a:xfrm>
            <a:off x="936937" y="2385903"/>
            <a:ext cx="4984124" cy="123525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939E0AC-1155-364C-9018-5846109734C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3332" b="26547"/>
          <a:stretch/>
        </p:blipFill>
        <p:spPr>
          <a:xfrm>
            <a:off x="936937" y="3604998"/>
            <a:ext cx="4984124" cy="137988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7BCE419-19CB-824C-BC84-86F16B77A9B6}"/>
              </a:ext>
            </a:extLst>
          </p:cNvPr>
          <p:cNvSpPr txBox="1"/>
          <p:nvPr/>
        </p:nvSpPr>
        <p:spPr>
          <a:xfrm>
            <a:off x="184150" y="1295779"/>
            <a:ext cx="205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31A36D2-FB44-5747-8FE1-017DE9DB8E09}"/>
              </a:ext>
            </a:extLst>
          </p:cNvPr>
          <p:cNvSpPr txBox="1"/>
          <p:nvPr/>
        </p:nvSpPr>
        <p:spPr>
          <a:xfrm>
            <a:off x="184151" y="8572728"/>
            <a:ext cx="303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247D07F-1FA0-8441-8F5D-8343189B7AC3}"/>
              </a:ext>
            </a:extLst>
          </p:cNvPr>
          <p:cNvGraphicFramePr>
            <a:graphicFrameLocks noGrp="1"/>
          </p:cNvGraphicFramePr>
          <p:nvPr/>
        </p:nvGraphicFramePr>
        <p:xfrm>
          <a:off x="702696" y="8894694"/>
          <a:ext cx="5460999" cy="1625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35100">
                  <a:extLst>
                    <a:ext uri="{9D8B030D-6E8A-4147-A177-3AD203B41FA5}">
                      <a16:colId xmlns:a16="http://schemas.microsoft.com/office/drawing/2014/main" val="2856109511"/>
                    </a:ext>
                  </a:extLst>
                </a:gridCol>
                <a:gridCol w="913478">
                  <a:extLst>
                    <a:ext uri="{9D8B030D-6E8A-4147-A177-3AD203B41FA5}">
                      <a16:colId xmlns:a16="http://schemas.microsoft.com/office/drawing/2014/main" val="2696814320"/>
                    </a:ext>
                  </a:extLst>
                </a:gridCol>
                <a:gridCol w="827232">
                  <a:extLst>
                    <a:ext uri="{9D8B030D-6E8A-4147-A177-3AD203B41FA5}">
                      <a16:colId xmlns:a16="http://schemas.microsoft.com/office/drawing/2014/main" val="1268449035"/>
                    </a:ext>
                  </a:extLst>
                </a:gridCol>
                <a:gridCol w="1457957">
                  <a:extLst>
                    <a:ext uri="{9D8B030D-6E8A-4147-A177-3AD203B41FA5}">
                      <a16:colId xmlns:a16="http://schemas.microsoft.com/office/drawing/2014/main" val="1576572035"/>
                    </a:ext>
                  </a:extLst>
                </a:gridCol>
                <a:gridCol w="827232">
                  <a:extLst>
                    <a:ext uri="{9D8B030D-6E8A-4147-A177-3AD203B41FA5}">
                      <a16:colId xmlns:a16="http://schemas.microsoft.com/office/drawing/2014/main" val="2977893990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First dose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Second dose</a:t>
                      </a:r>
                      <a:endParaRPr lang="en-GB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7809660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Virus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MT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SE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MT 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SE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041183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W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63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01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37.83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82.0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484801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E484K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4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57.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209.995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53.4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5465682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E484Q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1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77.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20.2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65.6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2249278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 dirty="0">
                          <a:effectLst/>
                        </a:rPr>
                        <a:t>L452R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326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859.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53.96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75.6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055759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L452R/E484Q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9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80.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41.17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>
                          <a:effectLst/>
                        </a:rPr>
                        <a:t>83.24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0471432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L452R/E484Q/P681R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8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5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55.78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</a:rPr>
                        <a:t>73.36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32114848"/>
                  </a:ext>
                </a:extLst>
              </a:tr>
            </a:tbl>
          </a:graphicData>
        </a:graphic>
      </p:graphicFrame>
      <p:pic>
        <p:nvPicPr>
          <p:cNvPr id="8" name="Picture 7">
            <a:extLst>
              <a:ext uri="{FF2B5EF4-FFF2-40B4-BE49-F238E27FC236}">
                <a16:creationId xmlns:a16="http://schemas.microsoft.com/office/drawing/2014/main" id="{2850584B-00EF-F645-9B00-136AE3AC2BD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82151"/>
          <a:stretch/>
        </p:blipFill>
        <p:spPr>
          <a:xfrm>
            <a:off x="936937" y="1237701"/>
            <a:ext cx="4984124" cy="122403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073BEE2-3E82-C041-8512-E806ED5376B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1296" b="-1689"/>
          <a:stretch/>
        </p:blipFill>
        <p:spPr>
          <a:xfrm>
            <a:off x="936937" y="4954981"/>
            <a:ext cx="4984124" cy="139849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10083D3-B0DF-2F4E-9831-BED7AFC8DB5F}"/>
              </a:ext>
            </a:extLst>
          </p:cNvPr>
          <p:cNvSpPr txBox="1"/>
          <p:nvPr/>
        </p:nvSpPr>
        <p:spPr>
          <a:xfrm>
            <a:off x="204397" y="6427492"/>
            <a:ext cx="465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F422CF3A-84DA-D34C-9167-5B19ABF2273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039"/>
          <a:stretch/>
        </p:blipFill>
        <p:spPr>
          <a:xfrm>
            <a:off x="4222207" y="6374758"/>
            <a:ext cx="1933098" cy="241920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F1991BCF-05E9-A34D-8649-266B624377F7}"/>
              </a:ext>
            </a:extLst>
          </p:cNvPr>
          <p:cNvSpPr txBox="1"/>
          <p:nvPr/>
        </p:nvSpPr>
        <p:spPr>
          <a:xfrm>
            <a:off x="3424805" y="6374757"/>
            <a:ext cx="465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0B51776C-29F6-354E-A314-1DBB6826144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419"/>
          <a:stretch/>
        </p:blipFill>
        <p:spPr>
          <a:xfrm>
            <a:off x="1273349" y="6382273"/>
            <a:ext cx="1941205" cy="2404175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FDE8D53-AD05-2D48-83BC-F23AC5BCD16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627" t="18737" r="90105" b="21343"/>
          <a:stretch/>
        </p:blipFill>
        <p:spPr>
          <a:xfrm>
            <a:off x="1000893" y="6382272"/>
            <a:ext cx="211279" cy="164996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ABC67D1-0A73-9B4B-9376-1DCEEC89B7A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627" t="18737" r="90105" b="21343"/>
          <a:stretch/>
        </p:blipFill>
        <p:spPr>
          <a:xfrm>
            <a:off x="3984092" y="6454206"/>
            <a:ext cx="202068" cy="157802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5B54C23B-DBC1-104A-B86F-28290A43568D}"/>
              </a:ext>
            </a:extLst>
          </p:cNvPr>
          <p:cNvSpPr txBox="1"/>
          <p:nvPr/>
        </p:nvSpPr>
        <p:spPr>
          <a:xfrm>
            <a:off x="-5276" y="10717964"/>
            <a:ext cx="28204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5197151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0AF3FDC-FCDF-294E-84A2-E60480C41D7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019"/>
          <a:stretch/>
        </p:blipFill>
        <p:spPr>
          <a:xfrm>
            <a:off x="207059" y="4333012"/>
            <a:ext cx="6604060" cy="193799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DA7F5CE-8C8A-674B-9EC8-495C6772AD0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517"/>
          <a:stretch/>
        </p:blipFill>
        <p:spPr>
          <a:xfrm>
            <a:off x="903499" y="1728423"/>
            <a:ext cx="4670691" cy="205059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FBC09D2-5303-4746-988B-A4C0F1A353C0}"/>
              </a:ext>
            </a:extLst>
          </p:cNvPr>
          <p:cNvSpPr txBox="1"/>
          <p:nvPr/>
        </p:nvSpPr>
        <p:spPr>
          <a:xfrm>
            <a:off x="544991" y="4141943"/>
            <a:ext cx="11131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A549_ACE2+TMPRSS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B1C4D03-7901-A64B-A836-59E6E9D3EF77}"/>
              </a:ext>
            </a:extLst>
          </p:cNvPr>
          <p:cNvSpPr txBox="1"/>
          <p:nvPr/>
        </p:nvSpPr>
        <p:spPr>
          <a:xfrm>
            <a:off x="2253795" y="4146437"/>
            <a:ext cx="12552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VeroE6_ACE2+TMPRSS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FD24BA8-F20B-1647-B4C7-A74B55E7B5A5}"/>
              </a:ext>
            </a:extLst>
          </p:cNvPr>
          <p:cNvSpPr txBox="1"/>
          <p:nvPr/>
        </p:nvSpPr>
        <p:spPr>
          <a:xfrm>
            <a:off x="3882391" y="4146437"/>
            <a:ext cx="1464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HEK293T_ACE2+TMPRSS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A39A3EA-B2A4-8F41-BEFD-8DDE6BBFDAED}"/>
              </a:ext>
            </a:extLst>
          </p:cNvPr>
          <p:cNvSpPr txBox="1"/>
          <p:nvPr/>
        </p:nvSpPr>
        <p:spPr>
          <a:xfrm>
            <a:off x="5684687" y="4141421"/>
            <a:ext cx="1464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HEK293T_ACE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47EC8E5-5D9C-DB41-A047-55F06E7CE1BC}"/>
              </a:ext>
            </a:extLst>
          </p:cNvPr>
          <p:cNvSpPr txBox="1"/>
          <p:nvPr/>
        </p:nvSpPr>
        <p:spPr>
          <a:xfrm>
            <a:off x="1390983" y="1476821"/>
            <a:ext cx="708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HeLa_ACE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96E4AEA-D336-E54A-AE46-86B700FA66A5}"/>
              </a:ext>
            </a:extLst>
          </p:cNvPr>
          <p:cNvSpPr txBox="1"/>
          <p:nvPr/>
        </p:nvSpPr>
        <p:spPr>
          <a:xfrm>
            <a:off x="4865199" y="1473356"/>
            <a:ext cx="708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H1299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2751F28-CF51-3C44-9D32-5FA8493E12AF}"/>
              </a:ext>
            </a:extLst>
          </p:cNvPr>
          <p:cNvSpPr txBox="1"/>
          <p:nvPr/>
        </p:nvSpPr>
        <p:spPr>
          <a:xfrm>
            <a:off x="3245212" y="1473356"/>
            <a:ext cx="708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CaLu-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02F2727-A834-0346-A971-784891E5F267}"/>
              </a:ext>
            </a:extLst>
          </p:cNvPr>
          <p:cNvSpPr txBox="1"/>
          <p:nvPr/>
        </p:nvSpPr>
        <p:spPr>
          <a:xfrm>
            <a:off x="-5276" y="10717964"/>
            <a:ext cx="28204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</a:t>
            </a:r>
            <a:r>
              <a:rPr lang="en-US"/>
              <a:t>Figure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651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8</Words>
  <Application>Microsoft Macintosh PowerPoint</Application>
  <PresentationFormat>Widescreen</PresentationFormat>
  <Paragraphs>5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21-06-18T19:02:18Z</dcterms:created>
  <dcterms:modified xsi:type="dcterms:W3CDTF">2021-06-18T19:03:24Z</dcterms:modified>
</cp:coreProperties>
</file>